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1296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A907AD-8CCD-48BB-AABB-5CAA8BAAF0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AF31B2-1C69-4C9E-8773-A7A1CE74D7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7A6B3C-1014-45D2-B3AB-51DBDF242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41911-8441-4B17-9EE6-C4C252F1E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0FFCD0-2C77-45BC-B0D4-D3A04868C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994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D16728-AB5B-4DC7-B14D-B2F95361D9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15B985-8D5D-48FF-9EAC-4D0C2BD74A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72F3E6-47C0-4E62-964E-D8F32CE66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82A4BC-FFAA-4AB8-9213-7E31D9639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3F1616-745F-43CA-B5E1-2BB047E45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690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7EEDBE-2DB3-48DA-B6C9-A675CD5CC5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3A4C2D-07F6-40FC-8CFC-9BE0C8ECCD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BBDF0A-4FF3-434F-965C-2E38D0714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FBC6E3-7393-434A-8627-CAFF0BC0F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C0389C-7FBC-4DAF-A8A8-5FBD1FFE6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507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67E334-7EDB-479F-9EAB-32AB73D8D7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978582-FBFF-4CAC-8C0A-4CA6FEA4DC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9CFCEB-9049-417D-8219-7029D45A7D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D1B754-EDDD-4F44-9101-C7FA00D23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CC05D3-5949-4AAD-BFBF-2CF25B0EC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231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16DD5-CD17-4D91-9729-92F06D421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E1DE99-F04A-451F-8310-696300242A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536A0E-6EF9-49F4-83AD-F8D6C7CD7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B4AE4A-C105-48E3-916A-81645B666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F1D545-74CA-4A71-859D-92093FFC5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69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8D7B29-FF0F-43A1-913F-C07CF5C6E3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B0CE26-CBE5-4501-8D29-3DC457611B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E55D53-892B-4E94-8B78-C6C10A7B9E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62C05F-4237-457B-8461-73B90EF6F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BAA306-AA1D-41B5-AC46-C3F6DFB1D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6BA9DA-99C5-40DB-9920-CAF967E38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986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598F83-380D-4A77-9662-C4D2475C69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548328-321A-4BC5-834C-49A183E0E9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6E41B5-0B07-4086-A26E-3AACF6E35D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FEAFE5-C7AA-4BEF-894A-FBB5D36AE3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CE5EF37-CAA8-40E7-8EE5-DF52052D95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E523AF-C289-474F-A039-80211B2B2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CDFCD0A-8190-427D-A935-8E669BB3F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664B12-03DA-407D-8415-527356C1C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380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6AF1D-E911-443C-AC03-54539BE2CD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EA36263-E44E-4CF8-9B49-E58105644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2A98B8-4781-4F31-8ADD-8D963A073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6F1391-C7EA-4A57-8C16-CB1424037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945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DD9727-C5CA-4B56-A202-2F77BB17A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9552CD-EA20-41B9-8064-F33851564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820F7F-AC79-4124-A73F-CE543375A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106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4417F2-C186-46FC-8FDB-87E8E3667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B89D8B-F226-4DBA-B94B-DB8F3F48D5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369A64-2145-47A5-9E2F-9D42DA4DA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C28CE9-195D-458D-AE4E-AA4709170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6A0C19-3218-4105-BC96-5D5CEDDF8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34F528-2FFA-48C2-865E-6788465F8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77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3C6E4E-9264-420C-B6FF-81EABB41E8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233B741-F043-4B1E-9FE8-E4AFF2D26E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EF92C9-3842-42BD-BEA9-2CC1BE6D0D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521572-C7C2-4E7B-9449-7F15A03FD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C42E14-954F-472D-A147-3AD74AF4D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0CDD61-43DE-41B0-9293-F6DCDA3361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39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E56FAAB-63A2-4497-AF08-4D97D49DC2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CF855A-1680-4DC5-B063-2AC7F9E08D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B8D335-3D57-4C79-9625-4630F36760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2B32C-9EEF-4F2D-B3C1-89B59148D168}" type="datetimeFigureOut">
              <a:rPr lang="en-US" smtClean="0"/>
              <a:t>12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DA7BC6-57FF-48F9-9300-B32B08BFCC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51C5FF-84BF-4788-AE6C-EDD6080DD6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392F53-0147-49FC-A046-9A2D3487F4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98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5C1A6740-3FED-4007-A388-C86E33D7588D}"/>
              </a:ext>
            </a:extLst>
          </p:cNvPr>
          <p:cNvCxnSpPr/>
          <p:nvPr/>
        </p:nvCxnSpPr>
        <p:spPr>
          <a:xfrm>
            <a:off x="1905000" y="2789368"/>
            <a:ext cx="13716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25">
            <a:extLst>
              <a:ext uri="{FF2B5EF4-FFF2-40B4-BE49-F238E27FC236}">
                <a16:creationId xmlns:a16="http://schemas.microsoft.com/office/drawing/2014/main" id="{D1ED31FC-C9A1-4326-B7A9-F40649A578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9800" y="2408368"/>
            <a:ext cx="7620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Input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0E03337-91C5-4FB6-B4FC-CE9E30F8BBA3}"/>
              </a:ext>
            </a:extLst>
          </p:cNvPr>
          <p:cNvCxnSpPr/>
          <p:nvPr/>
        </p:nvCxnSpPr>
        <p:spPr>
          <a:xfrm>
            <a:off x="3429000" y="2452818"/>
            <a:ext cx="52578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27">
            <a:extLst>
              <a:ext uri="{FF2B5EF4-FFF2-40B4-BE49-F238E27FC236}">
                <a16:creationId xmlns:a16="http://schemas.microsoft.com/office/drawing/2014/main" id="{9130B647-08FE-4264-BB0A-803E7C0972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1800" y="2127380"/>
            <a:ext cx="11430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ecreted</a:t>
            </a:r>
          </a:p>
        </p:txBody>
      </p:sp>
      <p:sp>
        <p:nvSpPr>
          <p:cNvPr id="8" name="TextBox 29">
            <a:extLst>
              <a:ext uri="{FF2B5EF4-FFF2-40B4-BE49-F238E27FC236}">
                <a16:creationId xmlns:a16="http://schemas.microsoft.com/office/drawing/2014/main" id="{B0839E82-0E06-4781-8772-056006E4D9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39200" y="3271968"/>
            <a:ext cx="13716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GFP-MMP2</a:t>
            </a:r>
          </a:p>
        </p:txBody>
      </p:sp>
      <p:sp>
        <p:nvSpPr>
          <p:cNvPr id="9" name="TextBox 30">
            <a:extLst>
              <a:ext uri="{FF2B5EF4-FFF2-40B4-BE49-F238E27FC236}">
                <a16:creationId xmlns:a16="http://schemas.microsoft.com/office/drawing/2014/main" id="{14E361DC-EA57-46B7-8C87-B7F11FAB48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5000" y="2806830"/>
            <a:ext cx="6096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10" name="TextBox 31">
            <a:extLst>
              <a:ext uri="{FF2B5EF4-FFF2-40B4-BE49-F238E27FC236}">
                <a16:creationId xmlns:a16="http://schemas.microsoft.com/office/drawing/2014/main" id="{5EE80A07-B12B-4880-8A39-2FE78A20E4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7938" y="2814768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sp>
        <p:nvSpPr>
          <p:cNvPr id="11" name="TextBox 32">
            <a:extLst>
              <a:ext uri="{FF2B5EF4-FFF2-40B4-BE49-F238E27FC236}">
                <a16:creationId xmlns:a16="http://schemas.microsoft.com/office/drawing/2014/main" id="{87C60247-B398-4A24-B684-A547B7E5F1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8663" y="3895855"/>
            <a:ext cx="7620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GIV</a:t>
            </a:r>
          </a:p>
        </p:txBody>
      </p:sp>
      <p:sp>
        <p:nvSpPr>
          <p:cNvPr id="12" name="TextBox 33">
            <a:extLst>
              <a:ext uri="{FF2B5EF4-FFF2-40B4-BE49-F238E27FC236}">
                <a16:creationId xmlns:a16="http://schemas.microsoft.com/office/drawing/2014/main" id="{7322C404-C9E6-4DC1-9F73-275D449E24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8663" y="4491168"/>
            <a:ext cx="9144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Actin</a:t>
            </a:r>
          </a:p>
        </p:txBody>
      </p:sp>
      <p:sp>
        <p:nvSpPr>
          <p:cNvPr id="13" name="TextBox 34">
            <a:extLst>
              <a:ext uri="{FF2B5EF4-FFF2-40B4-BE49-F238E27FC236}">
                <a16:creationId xmlns:a16="http://schemas.microsoft.com/office/drawing/2014/main" id="{BFC030E8-4300-4671-B4EB-F737CBDB24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6200" y="2482980"/>
            <a:ext cx="3810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0</a:t>
            </a:r>
          </a:p>
        </p:txBody>
      </p:sp>
      <p:sp>
        <p:nvSpPr>
          <p:cNvPr id="14" name="TextBox 35">
            <a:extLst>
              <a:ext uri="{FF2B5EF4-FFF2-40B4-BE49-F238E27FC236}">
                <a16:creationId xmlns:a16="http://schemas.microsoft.com/office/drawing/2014/main" id="{23764F46-B32B-4F22-9847-420A315FBD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8100" y="2502030"/>
            <a:ext cx="6858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24h</a:t>
            </a:r>
          </a:p>
        </p:txBody>
      </p:sp>
      <p:sp>
        <p:nvSpPr>
          <p:cNvPr id="15" name="TextBox 36">
            <a:extLst>
              <a:ext uri="{FF2B5EF4-FFF2-40B4-BE49-F238E27FC236}">
                <a16:creationId xmlns:a16="http://schemas.microsoft.com/office/drawing/2014/main" id="{98F13A3C-5FB2-47CB-9B42-EB54AAE468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67475" y="2482980"/>
            <a:ext cx="6858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48h</a:t>
            </a:r>
          </a:p>
        </p:txBody>
      </p:sp>
      <p:sp>
        <p:nvSpPr>
          <p:cNvPr id="16" name="TextBox 37">
            <a:extLst>
              <a:ext uri="{FF2B5EF4-FFF2-40B4-BE49-F238E27FC236}">
                <a16:creationId xmlns:a16="http://schemas.microsoft.com/office/drawing/2014/main" id="{C8F69150-40BE-42ED-8879-8779C7E4EC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37488" y="2487743"/>
            <a:ext cx="6858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60h</a:t>
            </a:r>
          </a:p>
        </p:txBody>
      </p:sp>
      <p:sp>
        <p:nvSpPr>
          <p:cNvPr id="17" name="TextBox 38">
            <a:extLst>
              <a:ext uri="{FF2B5EF4-FFF2-40B4-BE49-F238E27FC236}">
                <a16:creationId xmlns:a16="http://schemas.microsoft.com/office/drawing/2014/main" id="{5403D548-52AE-411F-A5AC-9432C0A0A2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67600" y="2829055"/>
            <a:ext cx="6096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18" name="TextBox 39">
            <a:extLst>
              <a:ext uri="{FF2B5EF4-FFF2-40B4-BE49-F238E27FC236}">
                <a16:creationId xmlns:a16="http://schemas.microsoft.com/office/drawing/2014/main" id="{AD7CC890-FDA7-43CD-8705-6D5E6BFD88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77200" y="2814768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0482318-6934-4C1D-9FDB-EAB0FDBD80E0}"/>
              </a:ext>
            </a:extLst>
          </p:cNvPr>
          <p:cNvCxnSpPr/>
          <p:nvPr/>
        </p:nvCxnSpPr>
        <p:spPr>
          <a:xfrm>
            <a:off x="7543800" y="2814768"/>
            <a:ext cx="1143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7319B7A8-10CB-4660-8A60-DEBE2EC6A727}"/>
              </a:ext>
            </a:extLst>
          </p:cNvPr>
          <p:cNvCxnSpPr/>
          <p:nvPr/>
        </p:nvCxnSpPr>
        <p:spPr>
          <a:xfrm>
            <a:off x="6186488" y="2821118"/>
            <a:ext cx="1143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9E71B4F-F601-475F-A336-6EC58622C5C4}"/>
              </a:ext>
            </a:extLst>
          </p:cNvPr>
          <p:cNvCxnSpPr/>
          <p:nvPr/>
        </p:nvCxnSpPr>
        <p:spPr>
          <a:xfrm>
            <a:off x="4829175" y="2819530"/>
            <a:ext cx="1143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021727E-4D3B-48B1-982D-380C39DA5624}"/>
              </a:ext>
            </a:extLst>
          </p:cNvPr>
          <p:cNvCxnSpPr/>
          <p:nvPr/>
        </p:nvCxnSpPr>
        <p:spPr>
          <a:xfrm>
            <a:off x="3505200" y="2819530"/>
            <a:ext cx="1143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46">
            <a:extLst>
              <a:ext uri="{FF2B5EF4-FFF2-40B4-BE49-F238E27FC236}">
                <a16:creationId xmlns:a16="http://schemas.microsoft.com/office/drawing/2014/main" id="{FEAE5C95-2566-474A-91D9-D4827ED351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0288" y="2856043"/>
            <a:ext cx="6096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24" name="TextBox 47">
            <a:extLst>
              <a:ext uri="{FF2B5EF4-FFF2-40B4-BE49-F238E27FC236}">
                <a16:creationId xmlns:a16="http://schemas.microsoft.com/office/drawing/2014/main" id="{2DA75282-5EA8-411A-BE18-6A11F0F06F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19888" y="2841755"/>
            <a:ext cx="7620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sp>
        <p:nvSpPr>
          <p:cNvPr id="25" name="TextBox 48">
            <a:extLst>
              <a:ext uri="{FF2B5EF4-FFF2-40B4-BE49-F238E27FC236}">
                <a16:creationId xmlns:a16="http://schemas.microsoft.com/office/drawing/2014/main" id="{613EF7BE-CF7F-47BE-A7ED-1D4DDA2006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6313" y="2856043"/>
            <a:ext cx="6096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26" name="TextBox 49">
            <a:extLst>
              <a:ext uri="{FF2B5EF4-FFF2-40B4-BE49-F238E27FC236}">
                <a16:creationId xmlns:a16="http://schemas.microsoft.com/office/drawing/2014/main" id="{FD30580B-1ED1-427F-ADBD-2AD2016FF8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5913" y="2841755"/>
            <a:ext cx="7620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sp>
        <p:nvSpPr>
          <p:cNvPr id="27" name="TextBox 50">
            <a:extLst>
              <a:ext uri="{FF2B5EF4-FFF2-40B4-BE49-F238E27FC236}">
                <a16:creationId xmlns:a16="http://schemas.microsoft.com/office/drawing/2014/main" id="{7F396222-A66E-4134-8B0B-E6C753A0D9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5663" y="2856043"/>
            <a:ext cx="6096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28" name="TextBox 51">
            <a:extLst>
              <a:ext uri="{FF2B5EF4-FFF2-40B4-BE49-F238E27FC236}">
                <a16:creationId xmlns:a16="http://schemas.microsoft.com/office/drawing/2014/main" id="{E3193B03-A241-4277-843C-A769EC99CF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5263" y="2841755"/>
            <a:ext cx="7620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sp>
        <p:nvSpPr>
          <p:cNvPr id="29" name="TextBox 52">
            <a:extLst>
              <a:ext uri="{FF2B5EF4-FFF2-40B4-BE49-F238E27FC236}">
                <a16:creationId xmlns:a16="http://schemas.microsoft.com/office/drawing/2014/main" id="{CFA7B170-1B53-4211-932F-A7EFDEACB9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86800" y="2433768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: EGF</a:t>
            </a:r>
          </a:p>
        </p:txBody>
      </p:sp>
      <p:pic>
        <p:nvPicPr>
          <p:cNvPr id="30" name="Picture 2" descr="H:\NICO LICOR new\0002985_01\700 GIV CT blot.tif">
            <a:extLst>
              <a:ext uri="{FF2B5EF4-FFF2-40B4-BE49-F238E27FC236}">
                <a16:creationId xmlns:a16="http://schemas.microsoft.com/office/drawing/2014/main" id="{5C460441-1245-4493-A72B-14A7AD0ED0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lum bright="-14000" contrast="48000"/>
          </a:blip>
          <a:srcRect l="6349" t="4762" r="60316" b="82539"/>
          <a:stretch>
            <a:fillRect/>
          </a:stretch>
        </p:blipFill>
        <p:spPr bwMode="auto">
          <a:xfrm>
            <a:off x="1924050" y="3760918"/>
            <a:ext cx="1400175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" name="Picture 3" descr="H:\NICO LICOR new\0002985_01\_800 GFP-MMP2_9 and actin blot.tif">
            <a:extLst>
              <a:ext uri="{FF2B5EF4-FFF2-40B4-BE49-F238E27FC236}">
                <a16:creationId xmlns:a16="http://schemas.microsoft.com/office/drawing/2014/main" id="{B6790000-51E6-4DA1-8176-6F02F5F754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l="6006" t="22021" r="57957" b="59959"/>
          <a:stretch>
            <a:fillRect/>
          </a:stretch>
        </p:blipFill>
        <p:spPr bwMode="auto">
          <a:xfrm>
            <a:off x="1905000" y="3270380"/>
            <a:ext cx="14478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2" name="Picture 4" descr="H:\NICO LICOR new\0002985_01\_800 GFP-MMP2_9 and actin blot.tif">
            <a:extLst>
              <a:ext uri="{FF2B5EF4-FFF2-40B4-BE49-F238E27FC236}">
                <a16:creationId xmlns:a16="http://schemas.microsoft.com/office/drawing/2014/main" id="{72F90B84-8B7F-4BE5-BEAB-A9326AF51F8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l="7555" t="60434" r="58450" b="28233"/>
          <a:stretch>
            <a:fillRect/>
          </a:stretch>
        </p:blipFill>
        <p:spPr bwMode="auto">
          <a:xfrm>
            <a:off x="1905000" y="4413380"/>
            <a:ext cx="143351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" name="Picture 5" descr="H:\NICO LICOR new\0003012_01\800 GFP blot pulldown.tif">
            <a:extLst>
              <a:ext uri="{FF2B5EF4-FFF2-40B4-BE49-F238E27FC236}">
                <a16:creationId xmlns:a16="http://schemas.microsoft.com/office/drawing/2014/main" id="{D7663313-1DE6-41E7-B841-262AD705BF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lum bright="10000" contrast="20000"/>
          </a:blip>
          <a:srcRect l="23756" t="14140" r="10632" b="63235"/>
          <a:stretch>
            <a:fillRect/>
          </a:stretch>
        </p:blipFill>
        <p:spPr bwMode="auto">
          <a:xfrm>
            <a:off x="3429000" y="3270380"/>
            <a:ext cx="533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4175966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9B232576-C626-4444-900A-331A3CF204DF}"/>
              </a:ext>
            </a:extLst>
          </p:cNvPr>
          <p:cNvCxnSpPr/>
          <p:nvPr/>
        </p:nvCxnSpPr>
        <p:spPr>
          <a:xfrm>
            <a:off x="2280139" y="3438892"/>
            <a:ext cx="13716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11">
            <a:extLst>
              <a:ext uri="{FF2B5EF4-FFF2-40B4-BE49-F238E27FC236}">
                <a16:creationId xmlns:a16="http://schemas.microsoft.com/office/drawing/2014/main" id="{2574B91A-4E8C-4B65-9D87-26A59A876B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4939" y="3057892"/>
            <a:ext cx="7620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Input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8C28B8C5-F922-45D5-A018-4EFB76B31F5F}"/>
              </a:ext>
            </a:extLst>
          </p:cNvPr>
          <p:cNvCxnSpPr/>
          <p:nvPr/>
        </p:nvCxnSpPr>
        <p:spPr>
          <a:xfrm>
            <a:off x="3804139" y="3100754"/>
            <a:ext cx="52578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13">
            <a:extLst>
              <a:ext uri="{FF2B5EF4-FFF2-40B4-BE49-F238E27FC236}">
                <a16:creationId xmlns:a16="http://schemas.microsoft.com/office/drawing/2014/main" id="{0BF1E15A-8D64-409C-BBB5-060D0733D8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6939" y="2775317"/>
            <a:ext cx="1143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ecreted</a:t>
            </a:r>
          </a:p>
        </p:txBody>
      </p:sp>
      <p:sp>
        <p:nvSpPr>
          <p:cNvPr id="6" name="TextBox 14">
            <a:extLst>
              <a:ext uri="{FF2B5EF4-FFF2-40B4-BE49-F238E27FC236}">
                <a16:creationId xmlns:a16="http://schemas.microsoft.com/office/drawing/2014/main" id="{0659B848-81D0-482C-B4F2-0EE8D73346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80139" y="3456354"/>
            <a:ext cx="6096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7" name="TextBox 15">
            <a:extLst>
              <a:ext uri="{FF2B5EF4-FFF2-40B4-BE49-F238E27FC236}">
                <a16:creationId xmlns:a16="http://schemas.microsoft.com/office/drawing/2014/main" id="{E6BBB5A1-AA50-4EFE-8BC1-9429ABCE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23077" y="3464292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sp>
        <p:nvSpPr>
          <p:cNvPr id="8" name="TextBox 16">
            <a:extLst>
              <a:ext uri="{FF2B5EF4-FFF2-40B4-BE49-F238E27FC236}">
                <a16:creationId xmlns:a16="http://schemas.microsoft.com/office/drawing/2014/main" id="{E4A978AF-FEBA-4A32-AAEC-1433F9E207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61339" y="3130917"/>
            <a:ext cx="381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0</a:t>
            </a:r>
          </a:p>
        </p:txBody>
      </p:sp>
      <p:sp>
        <p:nvSpPr>
          <p:cNvPr id="9" name="TextBox 17">
            <a:extLst>
              <a:ext uri="{FF2B5EF4-FFF2-40B4-BE49-F238E27FC236}">
                <a16:creationId xmlns:a16="http://schemas.microsoft.com/office/drawing/2014/main" id="{B1C788DF-57EB-49D8-A43D-81F8AAFEAA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3239" y="3151554"/>
            <a:ext cx="6858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24h</a:t>
            </a:r>
          </a:p>
        </p:txBody>
      </p:sp>
      <p:sp>
        <p:nvSpPr>
          <p:cNvPr id="10" name="TextBox 18">
            <a:extLst>
              <a:ext uri="{FF2B5EF4-FFF2-40B4-BE49-F238E27FC236}">
                <a16:creationId xmlns:a16="http://schemas.microsoft.com/office/drawing/2014/main" id="{2F5DD0E9-DFE9-4459-A25D-82B6D76E32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42614" y="3130917"/>
            <a:ext cx="6858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48h</a:t>
            </a:r>
          </a:p>
        </p:txBody>
      </p:sp>
      <p:sp>
        <p:nvSpPr>
          <p:cNvPr id="11" name="TextBox 19">
            <a:extLst>
              <a:ext uri="{FF2B5EF4-FFF2-40B4-BE49-F238E27FC236}">
                <a16:creationId xmlns:a16="http://schemas.microsoft.com/office/drawing/2014/main" id="{7753D29B-CDC6-4AD8-9A5B-A4D9AD0B06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12627" y="3137267"/>
            <a:ext cx="6858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60h</a:t>
            </a:r>
          </a:p>
        </p:txBody>
      </p:sp>
      <p:sp>
        <p:nvSpPr>
          <p:cNvPr id="12" name="TextBox 20">
            <a:extLst>
              <a:ext uri="{FF2B5EF4-FFF2-40B4-BE49-F238E27FC236}">
                <a16:creationId xmlns:a16="http://schemas.microsoft.com/office/drawing/2014/main" id="{CA64CF63-0B0B-4313-AC6C-F6ED687573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42739" y="3478579"/>
            <a:ext cx="6096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13" name="TextBox 21">
            <a:extLst>
              <a:ext uri="{FF2B5EF4-FFF2-40B4-BE49-F238E27FC236}">
                <a16:creationId xmlns:a16="http://schemas.microsoft.com/office/drawing/2014/main" id="{B379D26E-E07E-4C87-8C88-288CFA1B8E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52339" y="3464292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ECF8961-E2CE-4728-9BC3-788D8E9FE40E}"/>
              </a:ext>
            </a:extLst>
          </p:cNvPr>
          <p:cNvCxnSpPr/>
          <p:nvPr/>
        </p:nvCxnSpPr>
        <p:spPr>
          <a:xfrm>
            <a:off x="7918939" y="3464292"/>
            <a:ext cx="1143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305F246-8E5F-4483-9E94-B9860B5D20CF}"/>
              </a:ext>
            </a:extLst>
          </p:cNvPr>
          <p:cNvCxnSpPr/>
          <p:nvPr/>
        </p:nvCxnSpPr>
        <p:spPr>
          <a:xfrm>
            <a:off x="6561627" y="3470642"/>
            <a:ext cx="1143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0854D2A-28BA-442F-A5B9-E6DE998B3CAF}"/>
              </a:ext>
            </a:extLst>
          </p:cNvPr>
          <p:cNvCxnSpPr/>
          <p:nvPr/>
        </p:nvCxnSpPr>
        <p:spPr>
          <a:xfrm>
            <a:off x="5204314" y="3467467"/>
            <a:ext cx="1143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6F8EAEE-6A8A-49E8-9B7F-2E69CC963CC1}"/>
              </a:ext>
            </a:extLst>
          </p:cNvPr>
          <p:cNvCxnSpPr/>
          <p:nvPr/>
        </p:nvCxnSpPr>
        <p:spPr>
          <a:xfrm>
            <a:off x="3880339" y="3467467"/>
            <a:ext cx="1143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26">
            <a:extLst>
              <a:ext uri="{FF2B5EF4-FFF2-40B4-BE49-F238E27FC236}">
                <a16:creationId xmlns:a16="http://schemas.microsoft.com/office/drawing/2014/main" id="{B0D1237F-985B-4957-9761-E9576877BB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85427" y="3503979"/>
            <a:ext cx="6096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19" name="TextBox 27">
            <a:extLst>
              <a:ext uri="{FF2B5EF4-FFF2-40B4-BE49-F238E27FC236}">
                <a16:creationId xmlns:a16="http://schemas.microsoft.com/office/drawing/2014/main" id="{7622C38A-0566-4CF0-B7C6-A012F88941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95027" y="3489692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sp>
        <p:nvSpPr>
          <p:cNvPr id="20" name="TextBox 28">
            <a:extLst>
              <a:ext uri="{FF2B5EF4-FFF2-40B4-BE49-F238E27FC236}">
                <a16:creationId xmlns:a16="http://schemas.microsoft.com/office/drawing/2014/main" id="{5D7398E0-F92A-410E-9B91-A782A236E1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1452" y="3503979"/>
            <a:ext cx="6096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21" name="TextBox 29">
            <a:extLst>
              <a:ext uri="{FF2B5EF4-FFF2-40B4-BE49-F238E27FC236}">
                <a16:creationId xmlns:a16="http://schemas.microsoft.com/office/drawing/2014/main" id="{9591B89D-01ED-4CFF-8FBD-C90BC60C82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71052" y="3489692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sp>
        <p:nvSpPr>
          <p:cNvPr id="22" name="TextBox 30">
            <a:extLst>
              <a:ext uri="{FF2B5EF4-FFF2-40B4-BE49-F238E27FC236}">
                <a16:creationId xmlns:a16="http://schemas.microsoft.com/office/drawing/2014/main" id="{A8E394BA-8096-4380-B2EE-8D4E3C7B05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0802" y="3503979"/>
            <a:ext cx="6096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C</a:t>
            </a:r>
          </a:p>
        </p:txBody>
      </p:sp>
      <p:sp>
        <p:nvSpPr>
          <p:cNvPr id="23" name="TextBox 31">
            <a:extLst>
              <a:ext uri="{FF2B5EF4-FFF2-40B4-BE49-F238E27FC236}">
                <a16:creationId xmlns:a16="http://schemas.microsoft.com/office/drawing/2014/main" id="{F6A974A0-1720-4A63-AC0C-F756C9AD3F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0402" y="3489692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ShGiv</a:t>
            </a:r>
          </a:p>
        </p:txBody>
      </p:sp>
      <p:sp>
        <p:nvSpPr>
          <p:cNvPr id="24" name="TextBox 32">
            <a:extLst>
              <a:ext uri="{FF2B5EF4-FFF2-40B4-BE49-F238E27FC236}">
                <a16:creationId xmlns:a16="http://schemas.microsoft.com/office/drawing/2014/main" id="{709C05E0-0136-4120-A921-A98BAE8150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61939" y="3083292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: EGF</a:t>
            </a:r>
          </a:p>
        </p:txBody>
      </p:sp>
      <p:sp>
        <p:nvSpPr>
          <p:cNvPr id="25" name="TextBox 33">
            <a:extLst>
              <a:ext uri="{FF2B5EF4-FFF2-40B4-BE49-F238E27FC236}">
                <a16:creationId xmlns:a16="http://schemas.microsoft.com/office/drawing/2014/main" id="{0B6F1D67-E1D4-4309-AA33-83387D31AF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43802" y="4727942"/>
            <a:ext cx="762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GIV</a:t>
            </a:r>
          </a:p>
        </p:txBody>
      </p:sp>
      <p:sp>
        <p:nvSpPr>
          <p:cNvPr id="26" name="TextBox 34">
            <a:extLst>
              <a:ext uri="{FF2B5EF4-FFF2-40B4-BE49-F238E27FC236}">
                <a16:creationId xmlns:a16="http://schemas.microsoft.com/office/drawing/2014/main" id="{B0195AD3-4680-4FEE-9B33-4DD0EC3D7D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9514" y="5323254"/>
            <a:ext cx="9144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Actin</a:t>
            </a:r>
          </a:p>
        </p:txBody>
      </p:sp>
      <p:pic>
        <p:nvPicPr>
          <p:cNvPr id="27" name="Picture 2" descr="H:\NICO LICOR new\0002985_01\700 GIV CT blot.tif">
            <a:extLst>
              <a:ext uri="{FF2B5EF4-FFF2-40B4-BE49-F238E27FC236}">
                <a16:creationId xmlns:a16="http://schemas.microsoft.com/office/drawing/2014/main" id="{BD118D18-C453-478E-B6A7-3FD10F39D4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lum bright="2000" contrast="38000"/>
          </a:blip>
          <a:srcRect l="38095" t="4762" r="28571" b="82539"/>
          <a:stretch>
            <a:fillRect/>
          </a:stretch>
        </p:blipFill>
        <p:spPr bwMode="auto">
          <a:xfrm>
            <a:off x="2251564" y="4591417"/>
            <a:ext cx="1400175" cy="552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8" name="Picture 2" descr="H:\NICO LICOR new\0002985_01\_800 GFP-MMP2_9 and actin blot.tif">
            <a:extLst>
              <a:ext uri="{FF2B5EF4-FFF2-40B4-BE49-F238E27FC236}">
                <a16:creationId xmlns:a16="http://schemas.microsoft.com/office/drawing/2014/main" id="{759924EA-EA4C-455A-9C1A-55276801EF4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l="39655" t="20689" r="25862" b="67241"/>
          <a:stretch>
            <a:fillRect/>
          </a:stretch>
        </p:blipFill>
        <p:spPr bwMode="auto">
          <a:xfrm>
            <a:off x="2251564" y="3981817"/>
            <a:ext cx="1400175" cy="4905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" name="TextBox 36">
            <a:extLst>
              <a:ext uri="{FF2B5EF4-FFF2-40B4-BE49-F238E27FC236}">
                <a16:creationId xmlns:a16="http://schemas.microsoft.com/office/drawing/2014/main" id="{1CF6FFB8-A073-4882-BE34-6376D91F6B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4339" y="4023092"/>
            <a:ext cx="13716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>
                <a:latin typeface="Calibri" pitchFamily="34" charset="0"/>
              </a:rPr>
              <a:t>GFP-MMP9</a:t>
            </a:r>
          </a:p>
        </p:txBody>
      </p:sp>
      <p:pic>
        <p:nvPicPr>
          <p:cNvPr id="30" name="Picture 3" descr="H:\NICO LICOR new\0002985_01\_800 GFP-MMP2_9 and actin blot.tif">
            <a:extLst>
              <a:ext uri="{FF2B5EF4-FFF2-40B4-BE49-F238E27FC236}">
                <a16:creationId xmlns:a16="http://schemas.microsoft.com/office/drawing/2014/main" id="{BE8275C8-DCD7-48D9-84AA-E6D6DD39AE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l="39436" t="60564" r="26759" b="28169"/>
          <a:stretch>
            <a:fillRect/>
          </a:stretch>
        </p:blipFill>
        <p:spPr bwMode="auto">
          <a:xfrm>
            <a:off x="2251564" y="5234354"/>
            <a:ext cx="1400175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" name="Picture 4" descr="H:\NICO LICOR new\0003012_01\800 GFP blot pulldown.tif">
            <a:extLst>
              <a:ext uri="{FF2B5EF4-FFF2-40B4-BE49-F238E27FC236}">
                <a16:creationId xmlns:a16="http://schemas.microsoft.com/office/drawing/2014/main" id="{3C42AA2A-87E2-4186-9141-AFCBB15505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lum bright="20000" contrast="50000"/>
          </a:blip>
          <a:srcRect l="26379" t="53957" r="8873" b="22063"/>
          <a:stretch>
            <a:fillRect/>
          </a:stretch>
        </p:blipFill>
        <p:spPr bwMode="auto">
          <a:xfrm>
            <a:off x="3804139" y="3967529"/>
            <a:ext cx="541020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686486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2</Words>
  <Application>Microsoft Office PowerPoint</Application>
  <PresentationFormat>Widescreen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dipta Ghosh</dc:creator>
  <cp:lastModifiedBy>Pradipta Ghosh</cp:lastModifiedBy>
  <cp:revision>2</cp:revision>
  <dcterms:created xsi:type="dcterms:W3CDTF">2021-12-26T21:07:18Z</dcterms:created>
  <dcterms:modified xsi:type="dcterms:W3CDTF">2021-12-26T21:08:50Z</dcterms:modified>
</cp:coreProperties>
</file>